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8"/>
  </p:notesMasterIdLst>
  <p:sldIdLst>
    <p:sldId id="270" r:id="rId3"/>
    <p:sldId id="262" r:id="rId4"/>
    <p:sldId id="263" r:id="rId5"/>
    <p:sldId id="265" r:id="rId6"/>
    <p:sldId id="266" r:id="rId7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1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fobis" initials="i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3378" y="84"/>
      </p:cViewPr>
      <p:guideLst>
        <p:guide orient="horz" pos="381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F4E90C-2A0E-4E7E-B9B0-A4017BBE79CE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C67FFC-1BCD-4DF4-8E68-23E5694686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108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9145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2207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2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2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20833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224557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50882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38293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791388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6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8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6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24218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840403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668907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6"/>
            <a:ext cx="3471863" cy="866422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684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874022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6"/>
            <a:ext cx="3471863" cy="866422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053646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190471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2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2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1682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4058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8603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6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8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6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0881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9145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5171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6"/>
            <a:ext cx="3471863" cy="866422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7862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6"/>
            <a:ext cx="3471863" cy="866422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1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1202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7EAA7-EB6D-44E2-BB41-9A3DA5FF1AB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8457C-F438-4835-9329-83CA4DFA698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63613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4823C-075C-4A3C-A046-81455A21A7D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BA7F1-000C-47BD-B41E-E37F21E0B31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9078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8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3465" y="6919621"/>
            <a:ext cx="6347267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Figure S1 Known gene expression information for sex-specifically expressed genes.  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Top 20 sex-specifically expressed genes were analysed with </a:t>
            </a:r>
            <a:r>
              <a:rPr lang="en-GB" sz="1100" dirty="0" err="1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ThaleMine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database (https://apps.araport.org/thalemine/begin.do). Heat maps of RNA-</a:t>
            </a:r>
            <a:r>
              <a:rPr lang="en-GB" sz="1100" dirty="0" err="1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eq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based gene expression levels (Cheng et al., 2016) for each list were derived (stigma: upper, pollen: lower). * genes </a:t>
            </a:r>
            <a:r>
              <a:rPr lang="en-GB" sz="1100" dirty="0" err="1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analyzed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by RT-PCR and sequencing in Fig. </a:t>
            </a:r>
            <a:r>
              <a:rPr lang="en-GB" sz="1100" dirty="0">
                <a:latin typeface="Arial" panose="020B0604020202020204" pitchFamily="34" charset="0"/>
                <a:ea typeface="MS Mincho" panose="02020609040205080304" pitchFamily="49" charset="-128"/>
              </a:rPr>
              <a:t>3c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101443" y="1687868"/>
            <a:ext cx="6693150" cy="4572993"/>
            <a:chOff x="101443" y="1687868"/>
            <a:chExt cx="6693150" cy="457299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1000" t="39585" r="2127" b="21679"/>
            <a:stretch/>
          </p:blipFill>
          <p:spPr>
            <a:xfrm>
              <a:off x="358589" y="2153323"/>
              <a:ext cx="6193877" cy="1393111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768" t="36780" r="2191" b="14426"/>
            <a:stretch/>
          </p:blipFill>
          <p:spPr>
            <a:xfrm>
              <a:off x="343465" y="3747931"/>
              <a:ext cx="6204539" cy="175490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175809" y="1943009"/>
              <a:ext cx="2429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1B783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gma top 20 genes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75808" y="3524256"/>
              <a:ext cx="2429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762A8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len top 20 genes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28306" y="3204319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8306" y="2943169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8306" y="3408029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8306" y="2742519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8306" y="3340634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8306" y="3860634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8306" y="4385229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8306" y="4523844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28306" y="4455684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8306" y="4852165"/>
              <a:ext cx="170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>
              <a:off x="977629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1023023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4884906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4930300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101443" y="1687868"/>
              <a:ext cx="179509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emale tissue</a:t>
              </a:r>
            </a:p>
            <a:p>
              <a:pPr algn="ctr"/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arpel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281494" y="1687868"/>
              <a:ext cx="122005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le tissue</a:t>
              </a:r>
            </a:p>
            <a:p>
              <a:pPr algn="ctr"/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pollen)</a:t>
              </a:r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>
              <a:off x="6131667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>
              <a:off x="6186789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>
              <a:off x="6232185" y="2056048"/>
              <a:ext cx="0" cy="13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5574534" y="1687868"/>
              <a:ext cx="122005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age 12 inflorescence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550373" y="5151062"/>
              <a:ext cx="5636416" cy="3653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93711" y="5156771"/>
              <a:ext cx="35066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 rot="18817170">
              <a:off x="535645" y="5188017"/>
              <a:ext cx="4667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erial</a:t>
              </a:r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1045131" y="5156771"/>
              <a:ext cx="35066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Rectangle 40"/>
            <p:cNvSpPr/>
            <p:nvPr/>
          </p:nvSpPr>
          <p:spPr>
            <a:xfrm rot="18817170">
              <a:off x="339035" y="5461889"/>
              <a:ext cx="122341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rk-grown seedling</a:t>
              </a:r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1413131" y="5156771"/>
              <a:ext cx="11913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 rot="18817170">
              <a:off x="1785943" y="5153203"/>
              <a:ext cx="37061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2626193" y="5156771"/>
              <a:ext cx="22274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ctangle 46"/>
            <p:cNvSpPr/>
            <p:nvPr/>
          </p:nvSpPr>
          <p:spPr>
            <a:xfrm rot="18817170">
              <a:off x="2927179" y="5457247"/>
              <a:ext cx="121058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ght-grown seedling</a:t>
              </a:r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4975844" y="5156771"/>
              <a:ext cx="4153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 rot="18817170">
              <a:off x="4717979" y="5278534"/>
              <a:ext cx="71686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eptacle</a:t>
              </a:r>
            </a:p>
          </p:txBody>
        </p:sp>
        <p:cxnSp>
          <p:nvCxnSpPr>
            <p:cNvPr id="51" name="Straight Connector 50"/>
            <p:cNvCxnSpPr/>
            <p:nvPr/>
          </p:nvCxnSpPr>
          <p:spPr>
            <a:xfrm>
              <a:off x="5419368" y="5156771"/>
              <a:ext cx="32239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ctangle 52"/>
            <p:cNvSpPr/>
            <p:nvPr/>
          </p:nvSpPr>
          <p:spPr>
            <a:xfrm rot="18817170">
              <a:off x="5297952" y="5157845"/>
              <a:ext cx="3834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ot</a:t>
              </a:r>
            </a:p>
          </p:txBody>
        </p:sp>
        <p:cxnSp>
          <p:nvCxnSpPr>
            <p:cNvPr id="54" name="Straight Connector 53"/>
            <p:cNvCxnSpPr/>
            <p:nvPr/>
          </p:nvCxnSpPr>
          <p:spPr>
            <a:xfrm>
              <a:off x="5773035" y="5156771"/>
              <a:ext cx="1259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ctangle 55"/>
            <p:cNvSpPr/>
            <p:nvPr/>
          </p:nvSpPr>
          <p:spPr>
            <a:xfrm rot="18817170">
              <a:off x="4888143" y="5461889"/>
              <a:ext cx="122341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ot apical meristem</a:t>
              </a:r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5924784" y="5156771"/>
              <a:ext cx="1887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/>
            <p:cNvSpPr/>
            <p:nvPr/>
          </p:nvSpPr>
          <p:spPr>
            <a:xfrm rot="18817170">
              <a:off x="5005796" y="5492061"/>
              <a:ext cx="130676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oot apical meristem</a:t>
              </a:r>
            </a:p>
          </p:txBody>
        </p:sp>
      </p:grpSp>
      <p:sp>
        <p:nvSpPr>
          <p:cNvPr id="46" name="TextBox 32"/>
          <p:cNvSpPr txBox="1"/>
          <p:nvPr/>
        </p:nvSpPr>
        <p:spPr>
          <a:xfrm>
            <a:off x="1696087" y="6182852"/>
            <a:ext cx="38784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cript expression level (Transcript Per Million: TPM).</a:t>
            </a:r>
          </a:p>
          <a:p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coloring is a log2 scale of TPM. </a:t>
            </a:r>
          </a:p>
        </p:txBody>
      </p:sp>
    </p:spTree>
    <p:extLst>
      <p:ext uri="{BB962C8B-B14F-4D97-AF65-F5344CB8AC3E}">
        <p14:creationId xmlns:p14="http://schemas.microsoft.com/office/powerpoint/2010/main" val="22778465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r="1533"/>
          <a:stretch/>
        </p:blipFill>
        <p:spPr>
          <a:xfrm>
            <a:off x="1813560" y="2125927"/>
            <a:ext cx="3181350" cy="226074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2712"/>
          <a:stretch/>
        </p:blipFill>
        <p:spPr>
          <a:xfrm>
            <a:off x="1813560" y="4964388"/>
            <a:ext cx="3143250" cy="22632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91734" y="2106915"/>
            <a:ext cx="1074533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solidFill>
                  <a:srgbClr val="1B783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-0/</a:t>
            </a:r>
            <a:r>
              <a:rPr lang="en-US" sz="700" b="1" i="1" dirty="0">
                <a:solidFill>
                  <a:srgbClr val="1B783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RK14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81536" y="5023865"/>
            <a:ext cx="494929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solidFill>
                  <a:srgbClr val="762A8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4</a:t>
            </a:r>
          </a:p>
        </p:txBody>
      </p:sp>
      <p:sp>
        <p:nvSpPr>
          <p:cNvPr id="8" name="Rectangle 7"/>
          <p:cNvSpPr/>
          <p:nvPr/>
        </p:nvSpPr>
        <p:spPr>
          <a:xfrm>
            <a:off x="326536" y="7487450"/>
            <a:ext cx="6404451" cy="81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2 Depth coverage of Col-0/</a:t>
            </a:r>
            <a:r>
              <a:rPr lang="en-GB" sz="1100" b="1" i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RK14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C24 reference genomes after variants calling.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istributions of depth coverage before filtering were obtained by using GATK Depth Of Coverage. After checking depth coverage, Col-0/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RK14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variants were filtered at depth 3 and C24 variants were filtered at depth 6.</a:t>
            </a:r>
          </a:p>
        </p:txBody>
      </p:sp>
    </p:spTree>
    <p:extLst>
      <p:ext uri="{BB962C8B-B14F-4D97-AF65-F5344CB8AC3E}">
        <p14:creationId xmlns:p14="http://schemas.microsoft.com/office/powerpoint/2010/main" val="38368643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77091" y="3771912"/>
            <a:ext cx="6303818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1 Read length and depth of whole genome sequencing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l-0/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RK14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C24 genomes were sequenced with NextSeq500 platform (Illumina) applying paired-end sequencing (2×15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Sequence quality was checke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astQ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http://www.bioinformatics.babraham.ac.uk/projects/fastqc). Read parts with quality score less than 26 were trimmed and reads shorter than 50bp were discarded. F=forward sequence, R = reverse sequence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0" y="2301384"/>
            <a:ext cx="6819090" cy="5138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7464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77091" y="6736784"/>
            <a:ext cx="6303818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2 Length of sequenced RNA read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ur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A replicates selected from five samples at each pollination condition were sequenced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extSeq50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latform (Illumina) applying paired-end sequencing (2×7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 Sequence quality was checke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astQ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http://www.bioinformatics.babraham.ac.uk/projects/fastqc). Read parts with quality score less than 26 were trimmed and reads shorter than 40bp were discarded. F=forward sequence, R = reverse sequence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1" y="1719535"/>
            <a:ext cx="6705600" cy="3895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0327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4016913"/>
              </p:ext>
            </p:extLst>
          </p:nvPr>
        </p:nvGraphicFramePr>
        <p:xfrm>
          <a:off x="2019300" y="2151222"/>
          <a:ext cx="2819400" cy="2105025"/>
        </p:xfrm>
        <a:graphic>
          <a:graphicData uri="http://schemas.openxmlformats.org/drawingml/2006/table">
            <a:tbl>
              <a:tblPr/>
              <a:tblGrid>
                <a:gridCol w="939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1B7837"/>
                          </a:solidFill>
                          <a:effectLst/>
                          <a:latin typeface="Times New Roman" panose="02020603050405020304" pitchFamily="18" charset="0"/>
                        </a:rPr>
                        <a:t>Stigm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762A83"/>
                          </a:solidFill>
                          <a:effectLst/>
                          <a:latin typeface="Times New Roman" panose="02020603050405020304" pitchFamily="18" charset="0"/>
                        </a:rPr>
                        <a:t>Polle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0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60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10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60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tal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DBA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A5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0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60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10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60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tal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F0D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4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805135" y="4591008"/>
            <a:ext cx="563879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6  Number of up- and down-regulated gene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s up-regulated (FC &gt; 2.0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lt; 0.1) and down-regulated (FC &lt; -2.0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lt; 0.1) were selected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91911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4</TotalTime>
  <Words>435</Words>
  <Application>Microsoft Office PowerPoint</Application>
  <PresentationFormat>Grand écran</PresentationFormat>
  <Paragraphs>67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5</vt:i4>
      </vt:variant>
    </vt:vector>
  </HeadingPairs>
  <TitlesOfParts>
    <vt:vector size="12" baseType="lpstr">
      <vt:lpstr>MS Mincho</vt:lpstr>
      <vt:lpstr>Arial</vt:lpstr>
      <vt:lpstr>Calibri</vt:lpstr>
      <vt:lpstr>Calibri Light</vt:lpstr>
      <vt:lpstr>Times New Roman</vt:lpstr>
      <vt:lpstr>1_Office Theme</vt:lpstr>
      <vt:lpstr>2_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dera Chie</dc:creator>
  <cp:lastModifiedBy>isabelle</cp:lastModifiedBy>
  <cp:revision>102</cp:revision>
  <dcterms:created xsi:type="dcterms:W3CDTF">2018-04-19T15:02:28Z</dcterms:created>
  <dcterms:modified xsi:type="dcterms:W3CDTF">2020-10-05T09:38:38Z</dcterms:modified>
</cp:coreProperties>
</file>